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648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22EC03-C16E-4C3A-8E34-2885438531B3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19ACD0-0C78-48D7-9495-66001D27D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427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4063425"/>
              </p:ext>
            </p:extLst>
          </p:nvPr>
        </p:nvGraphicFramePr>
        <p:xfrm>
          <a:off x="761999" y="609604"/>
          <a:ext cx="5257802" cy="80772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385892"/>
                <a:gridCol w="1435955"/>
                <a:gridCol w="1435955"/>
              </a:tblGrid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V_cell_line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LSCR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KIL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X59M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9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21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184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33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30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2780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3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3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AOV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1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59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AOV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3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3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DOV1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EFO2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49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74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EFO2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20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20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ES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5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4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FUOV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5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51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0C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44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43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EY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31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21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EYA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33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31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IO180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8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8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OC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7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6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OC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5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5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IGROV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45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6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L4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PSCI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3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3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AW2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8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50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AW4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0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22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C31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55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55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C315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4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4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C31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6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6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CC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39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40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V90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0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8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VCA420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0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VCA42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05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8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VCA43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31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58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VCA43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6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VCAR10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VCAR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62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53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VCAR5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85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48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OVCAR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2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27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A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9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09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EA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25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25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EA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49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492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EO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43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407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EO1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3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37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EO2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5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EO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344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EO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4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4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KOV3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2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5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SW62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89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186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OV112D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26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26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OV21G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1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-0.11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  <a:tr h="1682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UPN251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28</a:t>
                      </a:r>
                      <a:endParaRPr lang="en-US" sz="100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284</a:t>
                      </a:r>
                      <a:endParaRPr lang="en-US" sz="1000" dirty="0">
                        <a:effectLst/>
                        <a:latin typeface="Cambria"/>
                        <a:ea typeface="MS Mincho"/>
                        <a:cs typeface="Times New Roman"/>
                      </a:endParaRPr>
                    </a:p>
                  </a:txBody>
                  <a:tcPr marL="45256" marR="45256" marT="0" marB="0"/>
                </a:tc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2432050" y="213360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7"/>
          <p:cNvSpPr txBox="1">
            <a:spLocks noChangeArrowheads="1"/>
          </p:cNvSpPr>
          <p:nvPr/>
        </p:nvSpPr>
        <p:spPr bwMode="auto">
          <a:xfrm>
            <a:off x="-15876" y="-15875"/>
            <a:ext cx="382587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1600" b="1" dirty="0" smtClean="0">
                <a:latin typeface="Arial" charset="0"/>
              </a:rPr>
              <a:t>Supplementary Table 1</a:t>
            </a:r>
            <a:endParaRPr lang="en-US" sz="1600" b="1" dirty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57282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1</TotalTime>
  <Words>187</Words>
  <Application>Microsoft Office PowerPoint</Application>
  <PresentationFormat>On-screen Show (4:3)</PresentationFormat>
  <Paragraphs>1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thik</dc:creator>
  <cp:lastModifiedBy>Nanjundan, Meera</cp:lastModifiedBy>
  <cp:revision>82</cp:revision>
  <dcterms:created xsi:type="dcterms:W3CDTF">2006-08-16T00:00:00Z</dcterms:created>
  <dcterms:modified xsi:type="dcterms:W3CDTF">2013-03-23T14:48:04Z</dcterms:modified>
</cp:coreProperties>
</file>